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501" r:id="rId2"/>
    <p:sldId id="500" r:id="rId3"/>
  </p:sldIdLst>
  <p:sldSz cx="7772400" cy="100584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80000"/>
    <a:srgbClr val="FF7F7F"/>
    <a:srgbClr val="203864"/>
    <a:srgbClr val="5799D5"/>
    <a:srgbClr val="7030A0"/>
    <a:srgbClr val="AA72D4"/>
    <a:srgbClr val="D9D9D9"/>
    <a:srgbClr val="385823"/>
    <a:srgbClr val="9DB4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1" autoAdjust="0"/>
    <p:restoredTop sz="94607" autoAdjust="0"/>
  </p:normalViewPr>
  <p:slideViewPr>
    <p:cSldViewPr snapToGrid="0" showGuides="1">
      <p:cViewPr varScale="1">
        <p:scale>
          <a:sx n="79" d="100"/>
          <a:sy n="79" d="100"/>
        </p:scale>
        <p:origin x="1116" y="90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22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4297-932A-4F71-8903-B6D1F1A62791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B4F4F-841E-4595-8617-427A2B050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796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015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AB7896EC-E3CD-4ADC-ADBD-BCB0E153EB35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3800" y="876300"/>
            <a:ext cx="18288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483" y="3373516"/>
            <a:ext cx="7435436" cy="2760584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015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B60371A-E4C3-41C0-9CCA-55B0B6D9B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35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01" indent="0" algn="ctr">
              <a:buNone/>
              <a:defRPr sz="1700"/>
            </a:lvl2pPr>
            <a:lvl3pPr marL="777202" indent="0" algn="ctr">
              <a:buNone/>
              <a:defRPr sz="1530"/>
            </a:lvl3pPr>
            <a:lvl4pPr marL="1165803" indent="0" algn="ctr">
              <a:buNone/>
              <a:defRPr sz="1360"/>
            </a:lvl4pPr>
            <a:lvl5pPr marL="1554404" indent="0" algn="ctr">
              <a:buNone/>
              <a:defRPr sz="1360"/>
            </a:lvl5pPr>
            <a:lvl6pPr marL="1943005" indent="0" algn="ctr">
              <a:buNone/>
              <a:defRPr sz="1360"/>
            </a:lvl6pPr>
            <a:lvl7pPr marL="2331606" indent="0" algn="ctr">
              <a:buNone/>
              <a:defRPr sz="1360"/>
            </a:lvl7pPr>
            <a:lvl8pPr marL="2720207" indent="0" algn="ctr">
              <a:buNone/>
              <a:defRPr sz="1360"/>
            </a:lvl8pPr>
            <a:lvl9pPr marL="3108808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6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4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2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0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02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03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0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0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60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20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8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7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65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5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81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0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01" indent="0">
              <a:buNone/>
              <a:defRPr sz="2380"/>
            </a:lvl2pPr>
            <a:lvl3pPr marL="777202" indent="0">
              <a:buNone/>
              <a:defRPr sz="2040"/>
            </a:lvl3pPr>
            <a:lvl4pPr marL="1165803" indent="0">
              <a:buNone/>
              <a:defRPr sz="1700"/>
            </a:lvl4pPr>
            <a:lvl5pPr marL="1554404" indent="0">
              <a:buNone/>
              <a:defRPr sz="1700"/>
            </a:lvl5pPr>
            <a:lvl6pPr marL="1943005" indent="0">
              <a:buNone/>
              <a:defRPr sz="1700"/>
            </a:lvl6pPr>
            <a:lvl7pPr marL="2331606" indent="0">
              <a:buNone/>
              <a:defRPr sz="1700"/>
            </a:lvl7pPr>
            <a:lvl8pPr marL="2720207" indent="0">
              <a:buNone/>
              <a:defRPr sz="1700"/>
            </a:lvl8pPr>
            <a:lvl9pPr marL="3108808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2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02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01" indent="-194301" algn="l" defTabSz="777202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02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04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305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5906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508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109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01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02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03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04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05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606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207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808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5313" y="531792"/>
            <a:ext cx="6703695" cy="638196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 Additional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MAGIC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components, gRNA cloning, and validation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x-dCas9(3.7) and x-Cas9(3.7)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MAG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usion genes cloned into pENTR221 R4-R3 (yellow). Additional effectors can be fused to x-dCas9(3.7) through uniqu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co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-terminal)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-terminus) restriction site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ENTR221 L1-R5 plasmids (purple) containing a x-Cas9(3.7) gRNA expression cassette driven by the mouse U6 (mU6) or human U6 (U6) promoter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ENTR221 L3-L2 plasmid (red) containing a 3xHA epitope tag for C-terminal fusion to x-Cas9(3.7) proteins and a U6-driven x-Cas9(3.7) gRNA expression cassett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,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ospac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ligonucleotides can be ligated in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a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ed gRNA expression cassettes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ospac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ligonucleotide templates where N represents th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, F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21-23mer Sa-Cas9 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E, G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20mer x-Cas9(3.7)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ospac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quenc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, E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U6 expression red sequences are required for ligation into 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a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ed gRNA expression cassett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F, G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expression driven by the mU6 promoter, purple sequences are required for ligation in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a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ed plasmid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-G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efficien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olII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itiation, the sens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ospac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ligonucleotide must begin with “G”, highlighted in blue, and must be added if not contained in the target sequenc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rG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striction digests of plasmid KU401, an Ad5 vector that contains two 5’ gRNA cassettes (7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rG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ragment; 274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ragment) in addition to a single 3’ gRNA cassette (11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rG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ragment; 536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ragment) analyzed on a 0.8% agarose gel. Expected fragment sizes (bps) f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rG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204 (not visible); 327 (not visible); 795, 840; 957; 1195; 1300; 2696; 4643; 11572; 13142. F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75 (not visible); 2081; 2748; 2937; 2988; 3549; 4597; 5324; 5362; 8010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I-J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EK293 cells were co-transfected with plasmids for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porter shown in Figure 6F, equimolar amounts of the indicated mCherry-P2A-dCas9 vectors, and the corresponding plasmids for Sa-Cas9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 x-Cas9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at only have single target site within the TRE promoter. 72h after transfection, cells wer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visualized by fluorescence microscopy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ular lysates were analyzed by immunoblot. “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” P2A products from Sa-dCas9 and x-dCas9 are designated by a red circle (•).</a:t>
            </a:r>
          </a:p>
        </p:txBody>
      </p:sp>
    </p:spTree>
    <p:extLst>
      <p:ext uri="{BB962C8B-B14F-4D97-AF65-F5344CB8AC3E}">
        <p14:creationId xmlns:p14="http://schemas.microsoft.com/office/powerpoint/2010/main" val="3942126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7736" y="7633890"/>
            <a:ext cx="2464337" cy="219935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DA7E5945-3D39-4248-B3DF-457F8555F4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7797" y="1399059"/>
            <a:ext cx="1954655" cy="114280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B428DA51-6E60-4738-9774-B7DE86A682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90829" y="1399059"/>
            <a:ext cx="1964998" cy="695505"/>
          </a:xfrm>
          <a:prstGeom prst="rect">
            <a:avLst/>
          </a:prstGeom>
        </p:spPr>
      </p:pic>
      <p:grpSp>
        <p:nvGrpSpPr>
          <p:cNvPr id="87" name="Group 86">
            <a:extLst>
              <a:ext uri="{FF2B5EF4-FFF2-40B4-BE49-F238E27FC236}">
                <a16:creationId xmlns:a16="http://schemas.microsoft.com/office/drawing/2014/main" xmlns="" id="{2C49D6BC-06D0-4B84-A91A-E46F78CFEFEB}"/>
              </a:ext>
            </a:extLst>
          </p:cNvPr>
          <p:cNvGrpSpPr/>
          <p:nvPr/>
        </p:nvGrpSpPr>
        <p:grpSpPr>
          <a:xfrm>
            <a:off x="318375" y="1399059"/>
            <a:ext cx="2281045" cy="2235335"/>
            <a:chOff x="318375" y="1399059"/>
            <a:chExt cx="2281045" cy="2235335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xmlns="" id="{76981870-CC32-4F30-BB13-B8596B07824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1570" y="1399059"/>
              <a:ext cx="1954655" cy="222355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xmlns="" id="{B1AD60FA-2091-4779-85C5-B770F68288C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18375" y="1628174"/>
              <a:ext cx="2281045" cy="2006220"/>
            </a:xfrm>
            <a:prstGeom prst="rect">
              <a:avLst/>
            </a:prstGeom>
          </p:spPr>
        </p:pic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7F2110D6-A9E1-4D5C-9074-D729BE0F0DD4}"/>
              </a:ext>
            </a:extLst>
          </p:cNvPr>
          <p:cNvSpPr txBox="1"/>
          <p:nvPr/>
        </p:nvSpPr>
        <p:spPr>
          <a:xfrm>
            <a:off x="173013" y="1098246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85217BE1-B61F-4B82-BCCE-ACA67A6C73F6}"/>
              </a:ext>
            </a:extLst>
          </p:cNvPr>
          <p:cNvSpPr txBox="1"/>
          <p:nvPr/>
        </p:nvSpPr>
        <p:spPr>
          <a:xfrm>
            <a:off x="2760490" y="1098246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E04B9C3F-4278-4B18-96E1-8EECB95AC635}"/>
              </a:ext>
            </a:extLst>
          </p:cNvPr>
          <p:cNvSpPr txBox="1"/>
          <p:nvPr/>
        </p:nvSpPr>
        <p:spPr>
          <a:xfrm>
            <a:off x="5163626" y="1069566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8BCA8020-D208-4888-8590-15598BCF17E7}"/>
              </a:ext>
            </a:extLst>
          </p:cNvPr>
          <p:cNvSpPr txBox="1"/>
          <p:nvPr/>
        </p:nvSpPr>
        <p:spPr>
          <a:xfrm>
            <a:off x="53248" y="3880936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EC60C046-A412-40D6-864C-880D5B36B21F}"/>
              </a:ext>
            </a:extLst>
          </p:cNvPr>
          <p:cNvSpPr txBox="1"/>
          <p:nvPr/>
        </p:nvSpPr>
        <p:spPr>
          <a:xfrm>
            <a:off x="120697" y="5863086"/>
            <a:ext cx="891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xmlns="" id="{DEDD59F3-DF08-4869-8D9E-95EB2F7B34B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97359" y="6125281"/>
            <a:ext cx="5308654" cy="1612074"/>
          </a:xfrm>
          <a:prstGeom prst="rect">
            <a:avLst/>
          </a:prstGeom>
        </p:spPr>
      </p:pic>
      <p:sp>
        <p:nvSpPr>
          <p:cNvPr id="38" name="Title 1">
            <a:extLst>
              <a:ext uri="{FF2B5EF4-FFF2-40B4-BE49-F238E27FC236}">
                <a16:creationId xmlns:a16="http://schemas.microsoft.com/office/drawing/2014/main" xmlns="" id="{75F68191-E210-423B-A213-BCD171324291}"/>
              </a:ext>
            </a:extLst>
          </p:cNvPr>
          <p:cNvSpPr txBox="1">
            <a:spLocks/>
          </p:cNvSpPr>
          <p:nvPr/>
        </p:nvSpPr>
        <p:spPr>
          <a:xfrm>
            <a:off x="0" y="121958"/>
            <a:ext cx="7772400" cy="63118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Supplemental Figure 4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A36AB91C-CDC9-45BC-879C-C757491BF2DB}"/>
              </a:ext>
            </a:extLst>
          </p:cNvPr>
          <p:cNvSpPr txBox="1"/>
          <p:nvPr/>
        </p:nvSpPr>
        <p:spPr>
          <a:xfrm>
            <a:off x="4254586" y="3827895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E122162-FCEE-4FED-8521-E6FEBF8123A5}"/>
              </a:ext>
            </a:extLst>
          </p:cNvPr>
          <p:cNvSpPr txBox="1"/>
          <p:nvPr/>
        </p:nvSpPr>
        <p:spPr>
          <a:xfrm>
            <a:off x="2042241" y="5896459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B2EFF459-32D8-49C8-8250-FA95B740DD6F}"/>
              </a:ext>
            </a:extLst>
          </p:cNvPr>
          <p:cNvSpPr txBox="1"/>
          <p:nvPr/>
        </p:nvSpPr>
        <p:spPr>
          <a:xfrm>
            <a:off x="2015736" y="8041860"/>
            <a:ext cx="39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4F0E67F-019A-41F7-989C-95BF5287DD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6946" y="6383508"/>
            <a:ext cx="1463167" cy="28105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6F4AA397-4A47-47EF-8C9F-EB3B2C2EDA1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2049" y="4058703"/>
            <a:ext cx="3718883" cy="167377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xmlns="" id="{576C3F7B-CFBB-45CA-BE85-A1BB362BE8C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78457" y="4058703"/>
            <a:ext cx="3114772" cy="1684859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328D4CC1-6F0C-4958-90DB-9E5DBC703937}"/>
              </a:ext>
            </a:extLst>
          </p:cNvPr>
          <p:cNvSpPr txBox="1"/>
          <p:nvPr/>
        </p:nvSpPr>
        <p:spPr>
          <a:xfrm>
            <a:off x="53248" y="4946676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D291EE50-D751-411F-B0FB-B9F6B74AEEE8}"/>
              </a:ext>
            </a:extLst>
          </p:cNvPr>
          <p:cNvSpPr txBox="1"/>
          <p:nvPr/>
        </p:nvSpPr>
        <p:spPr>
          <a:xfrm>
            <a:off x="4254586" y="4893635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236729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6</TotalTime>
  <Words>466</Words>
  <Application>Microsoft Office PowerPoint</Application>
  <PresentationFormat>Custom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uk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Haldeman</dc:creator>
  <cp:lastModifiedBy>Jonathan Haldeman</cp:lastModifiedBy>
  <cp:revision>625</cp:revision>
  <cp:lastPrinted>2018-11-09T17:51:23Z</cp:lastPrinted>
  <dcterms:created xsi:type="dcterms:W3CDTF">2016-09-16T14:04:00Z</dcterms:created>
  <dcterms:modified xsi:type="dcterms:W3CDTF">2018-11-27T23:38:13Z</dcterms:modified>
</cp:coreProperties>
</file>